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5620"/>
    <p:restoredTop sz="94650" autoAdjust="0"/>
  </p:normalViewPr>
  <p:slideViewPr>
    <p:cSldViewPr>
      <p:cViewPr>
        <p:scale>
          <a:sx n="125" d="100"/>
          <a:sy n="125" d="100"/>
        </p:scale>
        <p:origin x="-1170" y="-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689A1A-3021-40B0-8105-E9317343B333}" type="datetimeFigureOut">
              <a:rPr lang="es-ES" smtClean="0"/>
              <a:pPr/>
              <a:t>16/07/201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739681-8730-4A7B-8091-D3A54F2A8652}" type="slidenum">
              <a:rPr lang="es-ES" smtClean="0"/>
              <a:pPr/>
              <a:t>‹#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/>
        </p:nvGraphicFramePr>
        <p:xfrm>
          <a:off x="764704" y="899592"/>
          <a:ext cx="5256585" cy="5040560"/>
        </p:xfrm>
        <a:graphic>
          <a:graphicData uri="http://schemas.openxmlformats.org/drawingml/2006/table">
            <a:tbl>
              <a:tblPr/>
              <a:tblGrid>
                <a:gridCol w="1041279"/>
                <a:gridCol w="702551"/>
                <a:gridCol w="702551"/>
                <a:gridCol w="702551"/>
                <a:gridCol w="702551"/>
                <a:gridCol w="702551"/>
                <a:gridCol w="702551"/>
              </a:tblGrid>
              <a:tr h="373377">
                <a:tc gridSpan="7"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 smtClean="0">
                          <a:latin typeface="Times New Roman"/>
                          <a:ea typeface="Times New Roman"/>
                          <a:cs typeface="Times New Roman"/>
                        </a:rPr>
                        <a:t>Table S3</a:t>
                      </a:r>
                      <a:r>
                        <a:rPr lang="en-US" sz="800" dirty="0" smtClean="0">
                          <a:latin typeface="Times New Roman"/>
                          <a:ea typeface="Times New Roman"/>
                          <a:cs typeface="Times New Roman"/>
                        </a:rPr>
                        <a:t> </a:t>
                      </a:r>
                      <a:r>
                        <a:rPr lang="en-US" sz="800" dirty="0">
                          <a:latin typeface="Times New Roman"/>
                          <a:ea typeface="Times New Roman"/>
                          <a:cs typeface="Times New Roman"/>
                        </a:rPr>
                        <a:t>Absolute mRNA copy number of </a:t>
                      </a:r>
                      <a:r>
                        <a:rPr lang="en-US" sz="800" dirty="0" err="1">
                          <a:latin typeface="Times New Roman"/>
                          <a:ea typeface="Times New Roman"/>
                          <a:cs typeface="Times New Roman"/>
                        </a:rPr>
                        <a:t>ghrelin</a:t>
                      </a:r>
                      <a:r>
                        <a:rPr lang="en-US" sz="800" dirty="0">
                          <a:latin typeface="Times New Roman"/>
                          <a:ea typeface="Times New Roman"/>
                          <a:cs typeface="Times New Roman"/>
                        </a:rPr>
                        <a:t> axis components in human tissues included in the commercial panel of total RNA from </a:t>
                      </a:r>
                      <a:r>
                        <a:rPr lang="en-US" sz="800" dirty="0" err="1">
                          <a:latin typeface="Times New Roman"/>
                          <a:ea typeface="Times New Roman"/>
                          <a:cs typeface="Times New Roman"/>
                        </a:rPr>
                        <a:t>Clontech</a:t>
                      </a:r>
                      <a:endParaRPr lang="en-US" sz="9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20292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 b="1">
                          <a:latin typeface="Times New Roman"/>
                          <a:ea typeface="Times New Roman"/>
                          <a:cs typeface="Times New Roman"/>
                        </a:rPr>
                        <a:t>Tissue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 b="1" dirty="0" err="1">
                          <a:latin typeface="Times New Roman"/>
                          <a:ea typeface="Times New Roman"/>
                          <a:cs typeface="Times New Roman"/>
                        </a:rPr>
                        <a:t>Ghrelin</a:t>
                      </a:r>
                      <a:endParaRPr lang="en-US" sz="9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 b="1" dirty="0">
                          <a:latin typeface="Times New Roman" pitchFamily="18" charset="0"/>
                          <a:cs typeface="Times New Roman" pitchFamily="18" charset="0"/>
                        </a:rPr>
                        <a:t>In1-ghrelin</a:t>
                      </a:r>
                      <a:endParaRPr lang="en-US" sz="700" b="1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28631" marR="2863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 b="1" dirty="0">
                          <a:latin typeface="Times New Roman"/>
                          <a:ea typeface="Times New Roman"/>
                          <a:cs typeface="Times New Roman"/>
                        </a:rPr>
                        <a:t>GOAT</a:t>
                      </a:r>
                      <a:endParaRPr lang="en-US" sz="9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 b="1" kern="1200" dirty="0">
                          <a:solidFill>
                            <a:schemeClr val="tx1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GHSR1a</a:t>
                      </a:r>
                      <a:endParaRPr lang="en-US" sz="800" b="1" kern="1200" dirty="0">
                        <a:solidFill>
                          <a:schemeClr val="tx1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8631" marR="2863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 b="1" kern="1200" dirty="0">
                          <a:solidFill>
                            <a:schemeClr val="tx1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GHSR1b</a:t>
                      </a:r>
                      <a:endParaRPr lang="en-US" sz="800" b="1" kern="1200" dirty="0">
                        <a:solidFill>
                          <a:schemeClr val="tx1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8631" marR="2863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 b="1" dirty="0">
                          <a:latin typeface="Times New Roman"/>
                          <a:ea typeface="Times New Roman"/>
                          <a:cs typeface="Times New Roman"/>
                        </a:rPr>
                        <a:t>B-</a:t>
                      </a:r>
                      <a:r>
                        <a:rPr lang="es-ES" sz="800" b="1" dirty="0" err="1">
                          <a:latin typeface="Times New Roman"/>
                          <a:ea typeface="Times New Roman"/>
                          <a:cs typeface="Times New Roman"/>
                        </a:rPr>
                        <a:t>actin</a:t>
                      </a:r>
                      <a:endParaRPr lang="en-US" sz="9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292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 dirty="0" err="1">
                          <a:latin typeface="Times New Roman"/>
                          <a:ea typeface="Times New Roman"/>
                          <a:cs typeface="Times New Roman"/>
                        </a:rPr>
                        <a:t>Bone</a:t>
                      </a:r>
                      <a:r>
                        <a:rPr lang="es-ES" sz="800" dirty="0">
                          <a:latin typeface="Times New Roman"/>
                          <a:ea typeface="Times New Roman"/>
                          <a:cs typeface="Times New Roman"/>
                        </a:rPr>
                        <a:t> </a:t>
                      </a:r>
                      <a:r>
                        <a:rPr lang="es-ES" sz="800" dirty="0" err="1">
                          <a:latin typeface="Times New Roman"/>
                          <a:ea typeface="Times New Roman"/>
                          <a:cs typeface="Times New Roman"/>
                        </a:rPr>
                        <a:t>Marrow</a:t>
                      </a:r>
                      <a:endParaRPr lang="en-US" sz="9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4750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720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1150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n.d.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2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1880000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0292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Brain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1783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1140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1170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13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1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2680000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292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Fetal Brain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879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1740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 dirty="0">
                          <a:latin typeface="Times New Roman"/>
                          <a:ea typeface="Times New Roman"/>
                          <a:cs typeface="Times New Roman"/>
                        </a:rPr>
                        <a:t>2500</a:t>
                      </a:r>
                      <a:endParaRPr lang="en-US" sz="9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259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23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5470000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292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Fetal Liver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1287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84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1360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n.d.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n.d.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1010000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292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Heart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1689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365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1400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n.d.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2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677000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292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Kidney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6235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1140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972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n.d.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1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2430000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292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Liver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788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295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658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n.d.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n.d.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837000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292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Lung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3427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778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2360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12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3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5330000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292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Placenta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928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 dirty="0">
                          <a:latin typeface="Times New Roman"/>
                          <a:ea typeface="Times New Roman"/>
                          <a:cs typeface="Times New Roman"/>
                        </a:rPr>
                        <a:t>512</a:t>
                      </a:r>
                      <a:endParaRPr lang="en-US" sz="9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1680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3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19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2150000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292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Prostate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1434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969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953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n.d.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4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1370000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292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Skeletal Muscle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433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361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154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n.d.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2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243000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292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Spleen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4498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615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2580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n.d.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1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2440000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292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Testis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2341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2490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1270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186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19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2900000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292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Thymus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3618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6520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17200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2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3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6690000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292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Trachea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2100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510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421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5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3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1730000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292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Uterus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1218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975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1510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n.d.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2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5730000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292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Colon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980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641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1080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11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3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3460000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292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Small Intestine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18516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985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1040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11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2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3350000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292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Spinal Cord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2756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1050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907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292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11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3570000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292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Stomach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44229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680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1630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15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8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2360000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292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Pituitary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634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129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732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3060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554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313000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2921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800">
                          <a:latin typeface="Times New Roman"/>
                          <a:ea typeface="Times New Roman"/>
                          <a:cs typeface="Times New Roman"/>
                        </a:rPr>
                        <a:t>n.d.: non detected</a:t>
                      </a:r>
                      <a:endParaRPr lang="en-US" sz="9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s-ES" sz="8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s-ES" sz="8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s-ES" sz="8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s-ES" sz="8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s-ES" sz="80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s-ES" sz="800" dirty="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28631" marR="28631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Rectangle 1"/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9</TotalTime>
  <Words>198</Words>
  <Application>Microsoft Office PowerPoint</Application>
  <PresentationFormat>On-screen Show (4:3)</PresentationFormat>
  <Paragraphs>15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anuel David</dc:creator>
  <cp:lastModifiedBy>labuser</cp:lastModifiedBy>
  <cp:revision>16</cp:revision>
  <dcterms:created xsi:type="dcterms:W3CDTF">2010-03-02T14:57:06Z</dcterms:created>
  <dcterms:modified xsi:type="dcterms:W3CDTF">2011-07-16T19:03:15Z</dcterms:modified>
</cp:coreProperties>
</file>